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71" r:id="rId2"/>
    <p:sldId id="270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2E6A96B-7564-6743-A587-7AEB8C00BC05}" v="1" dt="2025-07-25T15:41:43.76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31348"/>
    <p:restoredTop sz="94758"/>
  </p:normalViewPr>
  <p:slideViewPr>
    <p:cSldViewPr snapToGrid="0">
      <p:cViewPr varScale="1">
        <p:scale>
          <a:sx n="92" d="100"/>
          <a:sy n="92" d="100"/>
        </p:scale>
        <p:origin x="184" y="8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80B2E0-D392-124F-857B-8B6259BDBC63}" type="datetimeFigureOut">
              <a:rPr lang="en-US" smtClean="0"/>
              <a:t>7/30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904E996-1285-1D46-BDE2-1065D68C2F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943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904E996-1285-1D46-BDE2-1065D68C2FA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749553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904E996-1285-1D46-BDE2-1065D68C2FAA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57827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1982FB-2A0C-510A-9405-81F05A45CE8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3B9CABD-E1BD-F524-DFEF-E910D7FB962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C23010-FC26-2776-A7C3-990BCCD0A5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1A5B1-81F5-E248-9F00-302DAC5D2F5D}" type="datetimeFigureOut">
              <a:rPr lang="en-US" smtClean="0"/>
              <a:t>7/3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69B209-7587-728E-1D6A-F9B53FF9B6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272836-4BCE-5AB3-A80D-E49FD34C1E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ECA62-BA7E-3040-82A2-CF60FCB4B9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0517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1689CE-43E3-E509-2272-A06C379A84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F5526E9-2EEA-45AE-FE6C-1691485AED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57E444-71B4-F573-EFC3-F22D23FE57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1A5B1-81F5-E248-9F00-302DAC5D2F5D}" type="datetimeFigureOut">
              <a:rPr lang="en-US" smtClean="0"/>
              <a:t>7/3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A94B07-3EEC-4792-6FA5-39CEE92D84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421C1A-ACB4-1495-FD9E-9DD3D13080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ECA62-BA7E-3040-82A2-CF60FCB4B9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80281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45C512E-AD82-E6A7-CFDC-A3EE0FA746E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F44B82D-7AA5-5C34-0DA1-F4D8C01FFF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C44CA2-BD7B-52F9-E1BA-770B00443B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1A5B1-81F5-E248-9F00-302DAC5D2F5D}" type="datetimeFigureOut">
              <a:rPr lang="en-US" smtClean="0"/>
              <a:t>7/3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DD43C7-9A1E-26F9-3EB8-1E27932BA4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C4804A-759A-E3D2-E365-A837D5B782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ECA62-BA7E-3040-82A2-CF60FCB4B9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76016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B37528-8A07-96A7-C562-09CD800BF8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F7A5BB-2693-848A-F20F-218DAC17FDE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D4BB43-BA84-F8B2-DC64-AC342D3891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1A5B1-81F5-E248-9F00-302DAC5D2F5D}" type="datetimeFigureOut">
              <a:rPr lang="en-US" smtClean="0"/>
              <a:t>7/3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8CE6A6-2E1A-0186-45A0-893696F138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1F6383-EB4E-1530-F2A3-DF95F4C132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ECA62-BA7E-3040-82A2-CF60FCB4B9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22975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2A986D-E8DE-CA65-05A5-EBAD659346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0DFA020-1E3F-0FDC-2065-453953585E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E1F415-0DFF-10D4-F430-08535EA146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1A5B1-81F5-E248-9F00-302DAC5D2F5D}" type="datetimeFigureOut">
              <a:rPr lang="en-US" smtClean="0"/>
              <a:t>7/3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83B5AD-8F2A-B9C7-883C-346FDE3BAB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4F206A-C753-10D8-961B-B54BFE46FC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ECA62-BA7E-3040-82A2-CF60FCB4B9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01805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2E32DF-F7B0-C656-9449-C0524914E7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CFC83B-04A5-7AFE-3095-8DE40DDBC54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889CFDE-19CE-14CF-6ACB-9B1D85462F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AF91673-E7BD-0FB2-9426-0F1889FE6C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1A5B1-81F5-E248-9F00-302DAC5D2F5D}" type="datetimeFigureOut">
              <a:rPr lang="en-US" smtClean="0"/>
              <a:t>7/30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3A7E7E-C363-9500-5D60-5569933309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748CC6-74D5-A287-7F5D-9CD3878195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ECA62-BA7E-3040-82A2-CF60FCB4B9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0152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42220E-7676-B829-8758-BAD88FF3B1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799174-E3EF-B7A3-BFAC-5F985CD3D6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2E3CE6E-F2DD-3037-1EF7-D082399A8A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BB388B0-2382-3840-7B1E-730406BB84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383E0BB-4114-6D2D-BBBE-CB36D51E9CB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E143C60-D269-57D6-0CBD-06D2095EE1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1A5B1-81F5-E248-9F00-302DAC5D2F5D}" type="datetimeFigureOut">
              <a:rPr lang="en-US" smtClean="0"/>
              <a:t>7/30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66DAEE7-2AE9-58EE-A177-29A543BE6F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4B7D9DF-636D-7040-19F9-E2E7C04344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ECA62-BA7E-3040-82A2-CF60FCB4B9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1366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2733B4-E54A-09B9-7309-6436B47BB3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B33476B-F1ED-4CE9-C7D3-1C6F22D5ED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1A5B1-81F5-E248-9F00-302DAC5D2F5D}" type="datetimeFigureOut">
              <a:rPr lang="en-US" smtClean="0"/>
              <a:t>7/30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E62E231-ED86-4405-33C7-B95D96B31C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36EBFA-4B67-6EC6-E93D-E748646C6A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ECA62-BA7E-3040-82A2-CF60FCB4B9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8916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310626E-5F91-A9CC-E0C9-6B6BED5CD1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1A5B1-81F5-E248-9F00-302DAC5D2F5D}" type="datetimeFigureOut">
              <a:rPr lang="en-US" smtClean="0"/>
              <a:t>7/30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34C30D9-001B-4E34-810B-D665201EA7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4F0D2B2-BA21-9D32-4D95-823F73BF6F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ECA62-BA7E-3040-82A2-CF60FCB4B9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55420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427ADC-AC12-9590-181E-3BACFB9A33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46B505-DC68-8389-72BC-DFB56A7052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F6026BC-74E6-F572-B958-904E426DA6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9589CC-0942-ECDF-873F-1D5AEC45CD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1A5B1-81F5-E248-9F00-302DAC5D2F5D}" type="datetimeFigureOut">
              <a:rPr lang="en-US" smtClean="0"/>
              <a:t>7/30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04B367C-B454-963B-32C8-7C50E1C0E2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9C8F7B-31BB-7607-C6A8-6F20DB38E5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ECA62-BA7E-3040-82A2-CF60FCB4B9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53955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A2AD4C-C15A-1F30-C841-D306B2FAB2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445258C-2B2D-A790-7B85-5241956A0FB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0427311-A852-B51A-2C10-2F8DBE6167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905F12-4C6F-45BB-E7C1-C5CCBF0FDD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1A5B1-81F5-E248-9F00-302DAC5D2F5D}" type="datetimeFigureOut">
              <a:rPr lang="en-US" smtClean="0"/>
              <a:t>7/30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9A5F93E-0ABD-7B41-72A8-63701559D9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781476A-7DFB-C6E3-DBDD-E5E16C5E42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ECA62-BA7E-3040-82A2-CF60FCB4B9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83974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93CA6CA-D19E-5CF7-0E42-EE35559807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1612BA-97C3-67A9-E1B9-C27E6663EF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F1E195-F2F3-44E4-5E2A-6B7CA096AA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5B1A5B1-81F5-E248-9F00-302DAC5D2F5D}" type="datetimeFigureOut">
              <a:rPr lang="en-US" smtClean="0"/>
              <a:t>7/3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BD4C7C-3A2F-E0E1-E507-661732869C6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F7326D-D2F1-B404-48AA-00F2C36C274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D0ECA62-BA7E-3040-82A2-CF60FCB4B9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04315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C9F9F34D-3965-254E-7299-FE47E606C7E1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9469" t="3672" r="19468" b="75072"/>
          <a:stretch/>
        </p:blipFill>
        <p:spPr>
          <a:xfrm>
            <a:off x="2117788" y="443388"/>
            <a:ext cx="4187687" cy="145774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E3A33A4D-60D5-6077-BBED-205A6BB82DD7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19180" t="24734" r="21110" b="51498"/>
          <a:stretch/>
        </p:blipFill>
        <p:spPr>
          <a:xfrm>
            <a:off x="2110786" y="1955510"/>
            <a:ext cx="4094922" cy="1630017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67467ED7-C9F4-B11F-6806-EE6427385625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17874" t="48059" r="21063" b="28173"/>
          <a:stretch/>
        </p:blipFill>
        <p:spPr>
          <a:xfrm>
            <a:off x="2110786" y="3606828"/>
            <a:ext cx="4187687" cy="1630017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0D47DC5D-FCD2-2E57-E27F-BB692E93C67E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17041" t="72045" r="21896" b="5628"/>
          <a:stretch/>
        </p:blipFill>
        <p:spPr>
          <a:xfrm>
            <a:off x="2113626" y="5266626"/>
            <a:ext cx="4187687" cy="1531230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8DB42C55-8570-EB10-B343-A07F8E9E6B4D}"/>
              </a:ext>
            </a:extLst>
          </p:cNvPr>
          <p:cNvSpPr txBox="1"/>
          <p:nvPr/>
        </p:nvSpPr>
        <p:spPr>
          <a:xfrm>
            <a:off x="1999448" y="830441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50-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E03B075-92AE-17BD-6715-9125D8BB6752}"/>
              </a:ext>
            </a:extLst>
          </p:cNvPr>
          <p:cNvSpPr txBox="1"/>
          <p:nvPr/>
        </p:nvSpPr>
        <p:spPr>
          <a:xfrm>
            <a:off x="1999448" y="1151496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50-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8ECED54-E78F-6FEF-C4AA-65A15A42A5B8}"/>
              </a:ext>
            </a:extLst>
          </p:cNvPr>
          <p:cNvSpPr txBox="1"/>
          <p:nvPr/>
        </p:nvSpPr>
        <p:spPr>
          <a:xfrm>
            <a:off x="1999448" y="1472551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00-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99E42DA-8E43-588D-922E-27503009BE98}"/>
              </a:ext>
            </a:extLst>
          </p:cNvPr>
          <p:cNvSpPr txBox="1"/>
          <p:nvPr/>
        </p:nvSpPr>
        <p:spPr>
          <a:xfrm>
            <a:off x="1992446" y="2476247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50-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A9999BD-DBEE-E4D7-0720-40078AF2BC0E}"/>
              </a:ext>
            </a:extLst>
          </p:cNvPr>
          <p:cNvSpPr txBox="1"/>
          <p:nvPr/>
        </p:nvSpPr>
        <p:spPr>
          <a:xfrm>
            <a:off x="1992446" y="2810241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50-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8666457-44AB-EE46-40F9-73C1F0076527}"/>
              </a:ext>
            </a:extLst>
          </p:cNvPr>
          <p:cNvSpPr txBox="1"/>
          <p:nvPr/>
        </p:nvSpPr>
        <p:spPr>
          <a:xfrm>
            <a:off x="1992446" y="3157174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00-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9519727-DDDB-D3BF-CD6C-58F5D6712FD6}"/>
              </a:ext>
            </a:extLst>
          </p:cNvPr>
          <p:cNvSpPr txBox="1"/>
          <p:nvPr/>
        </p:nvSpPr>
        <p:spPr>
          <a:xfrm>
            <a:off x="1988739" y="4191364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50-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94B84DF-64D2-28D4-FFA8-4A0F68E5411A}"/>
              </a:ext>
            </a:extLst>
          </p:cNvPr>
          <p:cNvSpPr txBox="1"/>
          <p:nvPr/>
        </p:nvSpPr>
        <p:spPr>
          <a:xfrm>
            <a:off x="1988739" y="4509860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50-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D8B4897-CB9D-69E8-DD7E-8CE78876E844}"/>
              </a:ext>
            </a:extLst>
          </p:cNvPr>
          <p:cNvSpPr txBox="1"/>
          <p:nvPr/>
        </p:nvSpPr>
        <p:spPr>
          <a:xfrm>
            <a:off x="1988739" y="4872291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00-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A4B8538-44F1-0D53-C3B0-D7EA176087C3}"/>
              </a:ext>
            </a:extLst>
          </p:cNvPr>
          <p:cNvSpPr txBox="1"/>
          <p:nvPr/>
        </p:nvSpPr>
        <p:spPr>
          <a:xfrm>
            <a:off x="1988739" y="5766063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50-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DBB880F-5E82-DB28-E5AC-4E1F4E5FE941}"/>
              </a:ext>
            </a:extLst>
          </p:cNvPr>
          <p:cNvSpPr txBox="1"/>
          <p:nvPr/>
        </p:nvSpPr>
        <p:spPr>
          <a:xfrm>
            <a:off x="1988739" y="6084559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50-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CC512DB-A15C-79E9-86D0-7386A3AC853B}"/>
              </a:ext>
            </a:extLst>
          </p:cNvPr>
          <p:cNvSpPr txBox="1"/>
          <p:nvPr/>
        </p:nvSpPr>
        <p:spPr>
          <a:xfrm>
            <a:off x="1988739" y="6446990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00-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9D2CA3EB-3EE4-D281-3FFD-C1F3D7E03459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17966" t="71624" r="17828" b="4991"/>
          <a:stretch/>
        </p:blipFill>
        <p:spPr>
          <a:xfrm>
            <a:off x="7456754" y="5209768"/>
            <a:ext cx="4403188" cy="1603718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33E1A836-7E6F-38E2-B9DE-92180545B769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17897" t="48987" r="17897" b="27629"/>
          <a:stretch/>
        </p:blipFill>
        <p:spPr>
          <a:xfrm>
            <a:off x="7460780" y="3576351"/>
            <a:ext cx="4403188" cy="1603718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4C14759B-76F7-B08B-9A57-E2F18A5F2234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l="19445" t="26059" r="19630" b="50556"/>
          <a:stretch/>
        </p:blipFill>
        <p:spPr>
          <a:xfrm>
            <a:off x="7546720" y="1912445"/>
            <a:ext cx="4178300" cy="1603718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2BA5CFEE-BFFA-494B-A588-A2E1A5BA3AF7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l="19473" t="2406" r="19601" b="72779"/>
          <a:stretch/>
        </p:blipFill>
        <p:spPr>
          <a:xfrm>
            <a:off x="7546720" y="126413"/>
            <a:ext cx="4178300" cy="1701800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D9B5C84D-9BB1-9D14-C2E8-4ACB972F7D3B}"/>
              </a:ext>
            </a:extLst>
          </p:cNvPr>
          <p:cNvSpPr txBox="1"/>
          <p:nvPr/>
        </p:nvSpPr>
        <p:spPr>
          <a:xfrm>
            <a:off x="7474190" y="4135463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-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13535E3-8C80-AB63-7A1C-331B849FBCF6}"/>
              </a:ext>
            </a:extLst>
          </p:cNvPr>
          <p:cNvSpPr txBox="1"/>
          <p:nvPr/>
        </p:nvSpPr>
        <p:spPr>
          <a:xfrm>
            <a:off x="7463824" y="4482377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5-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070F617-CC75-A71A-1924-0D1E3B259CB9}"/>
              </a:ext>
            </a:extLst>
          </p:cNvPr>
          <p:cNvSpPr txBox="1"/>
          <p:nvPr/>
        </p:nvSpPr>
        <p:spPr>
          <a:xfrm>
            <a:off x="7474190" y="3836229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-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D4E2D5C-AB64-1263-E340-59A72AB666D9}"/>
              </a:ext>
            </a:extLst>
          </p:cNvPr>
          <p:cNvSpPr txBox="1"/>
          <p:nvPr/>
        </p:nvSpPr>
        <p:spPr>
          <a:xfrm>
            <a:off x="7467722" y="4669702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0-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82065E8-4E4D-DD2D-FB31-8D7EABA61649}"/>
              </a:ext>
            </a:extLst>
          </p:cNvPr>
          <p:cNvSpPr txBox="1"/>
          <p:nvPr/>
        </p:nvSpPr>
        <p:spPr>
          <a:xfrm>
            <a:off x="7436708" y="5814279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-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DDC291A-1A1D-1042-D757-26C0DE5C5159}"/>
              </a:ext>
            </a:extLst>
          </p:cNvPr>
          <p:cNvSpPr txBox="1"/>
          <p:nvPr/>
        </p:nvSpPr>
        <p:spPr>
          <a:xfrm>
            <a:off x="7426342" y="6161193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5-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C4D507A9-17E1-BEE4-7C69-6FF61E9F0279}"/>
              </a:ext>
            </a:extLst>
          </p:cNvPr>
          <p:cNvSpPr txBox="1"/>
          <p:nvPr/>
        </p:nvSpPr>
        <p:spPr>
          <a:xfrm>
            <a:off x="7436708" y="5515045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-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A329B9C-2898-B0E3-5D59-48B528FECB62}"/>
              </a:ext>
            </a:extLst>
          </p:cNvPr>
          <p:cNvSpPr txBox="1"/>
          <p:nvPr/>
        </p:nvSpPr>
        <p:spPr>
          <a:xfrm>
            <a:off x="7430240" y="6348518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0-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006C0646-88A9-FDAE-4F45-3BE27EE31455}"/>
              </a:ext>
            </a:extLst>
          </p:cNvPr>
          <p:cNvSpPr txBox="1"/>
          <p:nvPr/>
        </p:nvSpPr>
        <p:spPr>
          <a:xfrm>
            <a:off x="7428677" y="750313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-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4ADCDD24-BFDB-8F5A-BF95-9511408B7EA0}"/>
              </a:ext>
            </a:extLst>
          </p:cNvPr>
          <p:cNvSpPr txBox="1"/>
          <p:nvPr/>
        </p:nvSpPr>
        <p:spPr>
          <a:xfrm>
            <a:off x="7418311" y="1097227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5-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0FC48FB-833A-EBF2-680F-43AD5C3FA639}"/>
              </a:ext>
            </a:extLst>
          </p:cNvPr>
          <p:cNvSpPr txBox="1"/>
          <p:nvPr/>
        </p:nvSpPr>
        <p:spPr>
          <a:xfrm>
            <a:off x="7428677" y="451079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-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9D7027A-2BBC-9C21-C3F2-F709CB62FBE0}"/>
              </a:ext>
            </a:extLst>
          </p:cNvPr>
          <p:cNvSpPr txBox="1"/>
          <p:nvPr/>
        </p:nvSpPr>
        <p:spPr>
          <a:xfrm>
            <a:off x="7422209" y="1284552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0-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A473A8B-2778-AE4F-3399-AF5332474A5F}"/>
              </a:ext>
            </a:extLst>
          </p:cNvPr>
          <p:cNvSpPr txBox="1"/>
          <p:nvPr/>
        </p:nvSpPr>
        <p:spPr>
          <a:xfrm>
            <a:off x="7428677" y="2489812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-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A9B1F92-A067-B341-4895-33DF87AFD0FA}"/>
              </a:ext>
            </a:extLst>
          </p:cNvPr>
          <p:cNvSpPr txBox="1"/>
          <p:nvPr/>
        </p:nvSpPr>
        <p:spPr>
          <a:xfrm>
            <a:off x="7418311" y="2836726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5-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46C9F17-B9C7-69D6-1560-47696A9E3425}"/>
              </a:ext>
            </a:extLst>
          </p:cNvPr>
          <p:cNvSpPr txBox="1"/>
          <p:nvPr/>
        </p:nvSpPr>
        <p:spPr>
          <a:xfrm>
            <a:off x="7428677" y="2190578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-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0A3E183-E972-8FEC-FD41-6189391E9F04}"/>
              </a:ext>
            </a:extLst>
          </p:cNvPr>
          <p:cNvSpPr txBox="1"/>
          <p:nvPr/>
        </p:nvSpPr>
        <p:spPr>
          <a:xfrm>
            <a:off x="7422209" y="3024051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0-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E5C05F2-0968-4BE1-53AA-840D59A1A3FE}"/>
              </a:ext>
            </a:extLst>
          </p:cNvPr>
          <p:cNvSpPr txBox="1"/>
          <p:nvPr/>
        </p:nvSpPr>
        <p:spPr>
          <a:xfrm>
            <a:off x="5480616" y="1575965"/>
            <a:ext cx="8407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-Ser2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CA5E18C-A714-1183-5FFB-B14444F7C064}"/>
              </a:ext>
            </a:extLst>
          </p:cNvPr>
          <p:cNvSpPr txBox="1"/>
          <p:nvPr/>
        </p:nvSpPr>
        <p:spPr>
          <a:xfrm>
            <a:off x="5404954" y="3226122"/>
            <a:ext cx="840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Ser5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8FE35B4-D2A8-DA4D-9EED-D08C82D120FC}"/>
              </a:ext>
            </a:extLst>
          </p:cNvPr>
          <p:cNvSpPr txBox="1"/>
          <p:nvPr/>
        </p:nvSpPr>
        <p:spPr>
          <a:xfrm>
            <a:off x="5451336" y="4843198"/>
            <a:ext cx="840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Ser7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87A341A-7112-D0D4-2FC7-67DDBF8DE27A}"/>
              </a:ext>
            </a:extLst>
          </p:cNvPr>
          <p:cNvSpPr txBox="1"/>
          <p:nvPr/>
        </p:nvSpPr>
        <p:spPr>
          <a:xfrm>
            <a:off x="10881068" y="1451372"/>
            <a:ext cx="9619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CDK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CD17F0E-98D9-A845-4213-3978AB83DF2D}"/>
              </a:ext>
            </a:extLst>
          </p:cNvPr>
          <p:cNvSpPr txBox="1"/>
          <p:nvPr/>
        </p:nvSpPr>
        <p:spPr>
          <a:xfrm>
            <a:off x="11016259" y="3183279"/>
            <a:ext cx="7585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DK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06370D6-D109-D2FF-5864-7466FB00A999}"/>
              </a:ext>
            </a:extLst>
          </p:cNvPr>
          <p:cNvSpPr txBox="1"/>
          <p:nvPr/>
        </p:nvSpPr>
        <p:spPr>
          <a:xfrm>
            <a:off x="11037468" y="4850702"/>
            <a:ext cx="7585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DK7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FB8BD31-9543-6076-7E1A-B4E73E94927B}"/>
              </a:ext>
            </a:extLst>
          </p:cNvPr>
          <p:cNvSpPr txBox="1"/>
          <p:nvPr/>
        </p:nvSpPr>
        <p:spPr>
          <a:xfrm>
            <a:off x="11037468" y="6488668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ß-acti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4972DFB-B4F3-8B6A-E53D-611E90F5A044}"/>
              </a:ext>
            </a:extLst>
          </p:cNvPr>
          <p:cNvSpPr txBox="1"/>
          <p:nvPr/>
        </p:nvSpPr>
        <p:spPr>
          <a:xfrm>
            <a:off x="5707729" y="6465497"/>
            <a:ext cx="613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PolII</a:t>
            </a:r>
            <a:endParaRPr 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2BBE430-C65E-9BEB-76F3-FC39A096873C}"/>
              </a:ext>
            </a:extLst>
          </p:cNvPr>
          <p:cNvSpPr txBox="1"/>
          <p:nvPr/>
        </p:nvSpPr>
        <p:spPr>
          <a:xfrm>
            <a:off x="-17913" y="6676"/>
            <a:ext cx="49677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Fig EV 3E (</a:t>
            </a:r>
            <a:r>
              <a:rPr lang="en-US" sz="2400" dirty="0" err="1"/>
              <a:t>Bioreps</a:t>
            </a:r>
            <a:r>
              <a:rPr lang="en-US" sz="2400" dirty="0"/>
              <a:t> for quantification)</a:t>
            </a:r>
          </a:p>
        </p:txBody>
      </p:sp>
    </p:spTree>
    <p:extLst>
      <p:ext uri="{BB962C8B-B14F-4D97-AF65-F5344CB8AC3E}">
        <p14:creationId xmlns:p14="http://schemas.microsoft.com/office/powerpoint/2010/main" val="14896616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600C31B-142E-BA10-02D5-5A44C463880A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9074" t="4258" r="20185" b="72964"/>
          <a:stretch/>
        </p:blipFill>
        <p:spPr>
          <a:xfrm>
            <a:off x="1133871" y="567616"/>
            <a:ext cx="4165600" cy="15621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18BEF1C-00F7-31D8-0733-B15B40941A67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9629" t="25839" r="19629" b="52963"/>
          <a:stretch/>
        </p:blipFill>
        <p:spPr>
          <a:xfrm>
            <a:off x="1133871" y="2170279"/>
            <a:ext cx="4165600" cy="145376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A33DBA6-4B24-6E8E-5283-869FA10D5BF3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18519" t="46296" r="17778" b="29148"/>
          <a:stretch/>
        </p:blipFill>
        <p:spPr>
          <a:xfrm>
            <a:off x="7347363" y="3421610"/>
            <a:ext cx="4368800" cy="168402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247B6F4-CECE-28B1-27A0-B0F2F0C29579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18148" t="70212" r="18148" b="5232"/>
          <a:stretch/>
        </p:blipFill>
        <p:spPr>
          <a:xfrm>
            <a:off x="7347363" y="5173980"/>
            <a:ext cx="4368800" cy="168402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3E234D1C-9995-A2C8-FB99-1AE09736FF00}"/>
              </a:ext>
            </a:extLst>
          </p:cNvPr>
          <p:cNvSpPr txBox="1"/>
          <p:nvPr/>
        </p:nvSpPr>
        <p:spPr>
          <a:xfrm>
            <a:off x="7347363" y="5782529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-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08C5AD6-8E2B-692A-A520-E57D2FA7645E}"/>
              </a:ext>
            </a:extLst>
          </p:cNvPr>
          <p:cNvSpPr txBox="1"/>
          <p:nvPr/>
        </p:nvSpPr>
        <p:spPr>
          <a:xfrm>
            <a:off x="7336997" y="6146219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5-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26B907C-0E19-6EA1-2BAD-4DF83BC247C6}"/>
              </a:ext>
            </a:extLst>
          </p:cNvPr>
          <p:cNvSpPr txBox="1"/>
          <p:nvPr/>
        </p:nvSpPr>
        <p:spPr>
          <a:xfrm>
            <a:off x="7347363" y="5483295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-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907AD93-CD41-0481-336D-F014E5803951}"/>
              </a:ext>
            </a:extLst>
          </p:cNvPr>
          <p:cNvSpPr txBox="1"/>
          <p:nvPr/>
        </p:nvSpPr>
        <p:spPr>
          <a:xfrm>
            <a:off x="7340895" y="6316768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0-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A8CA8D6-552D-D68A-BDEB-32673B7AD20E}"/>
              </a:ext>
            </a:extLst>
          </p:cNvPr>
          <p:cNvSpPr txBox="1"/>
          <p:nvPr/>
        </p:nvSpPr>
        <p:spPr>
          <a:xfrm>
            <a:off x="7308929" y="4056350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-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62A2B92-7DF9-DC93-1076-C11336AEA3E2}"/>
              </a:ext>
            </a:extLst>
          </p:cNvPr>
          <p:cNvSpPr txBox="1"/>
          <p:nvPr/>
        </p:nvSpPr>
        <p:spPr>
          <a:xfrm>
            <a:off x="7298563" y="4420040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5-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9609E6C-0FDF-20D6-5AC5-60CE23593591}"/>
              </a:ext>
            </a:extLst>
          </p:cNvPr>
          <p:cNvSpPr txBox="1"/>
          <p:nvPr/>
        </p:nvSpPr>
        <p:spPr>
          <a:xfrm>
            <a:off x="7308929" y="3757116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-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CBD84E7-6FC5-1BBE-56B9-F8BFC59C9DD1}"/>
              </a:ext>
            </a:extLst>
          </p:cNvPr>
          <p:cNvSpPr txBox="1"/>
          <p:nvPr/>
        </p:nvSpPr>
        <p:spPr>
          <a:xfrm>
            <a:off x="7302461" y="4590589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0-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FB9CF834-D2F9-B22B-47F4-14E9037C1001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21717" t="2606" r="14990" b="75596"/>
          <a:stretch/>
        </p:blipFill>
        <p:spPr>
          <a:xfrm>
            <a:off x="1094086" y="3567164"/>
            <a:ext cx="4340630" cy="1494908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9270E4E0-FB25-08CF-52F1-F9B5EA27ECD9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20091" t="23535" r="16616" b="51537"/>
          <a:stretch/>
        </p:blipFill>
        <p:spPr>
          <a:xfrm>
            <a:off x="1094086" y="5111313"/>
            <a:ext cx="4340630" cy="1709531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7EB3AADC-7B61-6667-6427-F74473DA6A24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19757" t="70545" r="16949" b="5940"/>
          <a:stretch/>
        </p:blipFill>
        <p:spPr>
          <a:xfrm>
            <a:off x="7336997" y="1774957"/>
            <a:ext cx="4340629" cy="161267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12D3CDA6-074B-0481-4526-D03B3AFE8274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20144" t="47975" r="16563" b="29205"/>
          <a:stretch/>
        </p:blipFill>
        <p:spPr>
          <a:xfrm>
            <a:off x="7336997" y="111444"/>
            <a:ext cx="4340630" cy="1565031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A81684AF-3501-E2F5-53CA-DD36BF9E41DF}"/>
              </a:ext>
            </a:extLst>
          </p:cNvPr>
          <p:cNvSpPr txBox="1"/>
          <p:nvPr/>
        </p:nvSpPr>
        <p:spPr>
          <a:xfrm>
            <a:off x="7277404" y="2330171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-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3F27F3D-8795-E8F5-CBD3-5A37734AED18}"/>
              </a:ext>
            </a:extLst>
          </p:cNvPr>
          <p:cNvSpPr txBox="1"/>
          <p:nvPr/>
        </p:nvSpPr>
        <p:spPr>
          <a:xfrm>
            <a:off x="7267038" y="2693861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5-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6742F76-7185-74E7-0347-C485472CC4BA}"/>
              </a:ext>
            </a:extLst>
          </p:cNvPr>
          <p:cNvSpPr txBox="1"/>
          <p:nvPr/>
        </p:nvSpPr>
        <p:spPr>
          <a:xfrm>
            <a:off x="7277404" y="2030937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-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B3615A5-5781-2780-3471-1B80AC907FD4}"/>
              </a:ext>
            </a:extLst>
          </p:cNvPr>
          <p:cNvSpPr txBox="1"/>
          <p:nvPr/>
        </p:nvSpPr>
        <p:spPr>
          <a:xfrm>
            <a:off x="7270936" y="2864410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0-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C87BFB3-729A-3A5F-F389-03F495D073D7}"/>
              </a:ext>
            </a:extLst>
          </p:cNvPr>
          <p:cNvSpPr txBox="1"/>
          <p:nvPr/>
        </p:nvSpPr>
        <p:spPr>
          <a:xfrm>
            <a:off x="7252457" y="744745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-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DBF9BCE-B639-EE99-8071-A87AD9FFD39C}"/>
              </a:ext>
            </a:extLst>
          </p:cNvPr>
          <p:cNvSpPr txBox="1"/>
          <p:nvPr/>
        </p:nvSpPr>
        <p:spPr>
          <a:xfrm>
            <a:off x="7242091" y="1108435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5-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A8CC0F8-8D93-3639-411B-0A4FD8E4E3D3}"/>
              </a:ext>
            </a:extLst>
          </p:cNvPr>
          <p:cNvSpPr txBox="1"/>
          <p:nvPr/>
        </p:nvSpPr>
        <p:spPr>
          <a:xfrm>
            <a:off x="7252457" y="445511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-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3C6A68D-1FC0-8D57-B6AC-1638C978C4F6}"/>
              </a:ext>
            </a:extLst>
          </p:cNvPr>
          <p:cNvSpPr txBox="1"/>
          <p:nvPr/>
        </p:nvSpPr>
        <p:spPr>
          <a:xfrm>
            <a:off x="7245989" y="1278984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0-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572D2A4-C989-EC47-FA85-70DDDD5F572A}"/>
              </a:ext>
            </a:extLst>
          </p:cNvPr>
          <p:cNvSpPr txBox="1"/>
          <p:nvPr/>
        </p:nvSpPr>
        <p:spPr>
          <a:xfrm>
            <a:off x="1012052" y="1130785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50-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1C5DAF8-2928-6AEB-56D1-4CC48F13D665}"/>
              </a:ext>
            </a:extLst>
          </p:cNvPr>
          <p:cNvSpPr txBox="1"/>
          <p:nvPr/>
        </p:nvSpPr>
        <p:spPr>
          <a:xfrm>
            <a:off x="1012052" y="1451840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50-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3BFEA71-E017-33FE-0748-AB362BDEAC55}"/>
              </a:ext>
            </a:extLst>
          </p:cNvPr>
          <p:cNvSpPr txBox="1"/>
          <p:nvPr/>
        </p:nvSpPr>
        <p:spPr>
          <a:xfrm>
            <a:off x="1012052" y="1772895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00-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DC8013BC-0151-060B-21A5-49111F01A2BB}"/>
              </a:ext>
            </a:extLst>
          </p:cNvPr>
          <p:cNvSpPr txBox="1"/>
          <p:nvPr/>
        </p:nvSpPr>
        <p:spPr>
          <a:xfrm>
            <a:off x="1012052" y="2582318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50-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6A97C59-64AB-7CE6-DD81-A4ECD427139A}"/>
              </a:ext>
            </a:extLst>
          </p:cNvPr>
          <p:cNvSpPr txBox="1"/>
          <p:nvPr/>
        </p:nvSpPr>
        <p:spPr>
          <a:xfrm>
            <a:off x="1012052" y="2903373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50-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29612BB-6874-5662-5E84-63860BE98254}"/>
              </a:ext>
            </a:extLst>
          </p:cNvPr>
          <p:cNvSpPr txBox="1"/>
          <p:nvPr/>
        </p:nvSpPr>
        <p:spPr>
          <a:xfrm>
            <a:off x="1012052" y="3224428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00-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CC9917F-63ED-ED97-22DB-2D01E3AA3CC3}"/>
              </a:ext>
            </a:extLst>
          </p:cNvPr>
          <p:cNvSpPr txBox="1"/>
          <p:nvPr/>
        </p:nvSpPr>
        <p:spPr>
          <a:xfrm>
            <a:off x="1079203" y="3982158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50-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C3403D4-BB8A-D335-134C-333DC9E5E4B2}"/>
              </a:ext>
            </a:extLst>
          </p:cNvPr>
          <p:cNvSpPr txBox="1"/>
          <p:nvPr/>
        </p:nvSpPr>
        <p:spPr>
          <a:xfrm>
            <a:off x="1079203" y="4303213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50-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D03D317B-BC90-C90E-457A-6284C92F97F5}"/>
              </a:ext>
            </a:extLst>
          </p:cNvPr>
          <p:cNvSpPr txBox="1"/>
          <p:nvPr/>
        </p:nvSpPr>
        <p:spPr>
          <a:xfrm>
            <a:off x="1079203" y="4624268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00-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3332F36-B121-5509-7067-63A7D646BBE0}"/>
              </a:ext>
            </a:extLst>
          </p:cNvPr>
          <p:cNvSpPr txBox="1"/>
          <p:nvPr/>
        </p:nvSpPr>
        <p:spPr>
          <a:xfrm>
            <a:off x="1102953" y="5728235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50-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16C82E3-FAE2-EF66-815E-E2B1DE686324}"/>
              </a:ext>
            </a:extLst>
          </p:cNvPr>
          <p:cNvSpPr txBox="1"/>
          <p:nvPr/>
        </p:nvSpPr>
        <p:spPr>
          <a:xfrm>
            <a:off x="1102953" y="6049290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50-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7FA53AE-72F3-9B99-F5A9-F0A058306B18}"/>
              </a:ext>
            </a:extLst>
          </p:cNvPr>
          <p:cNvSpPr txBox="1"/>
          <p:nvPr/>
        </p:nvSpPr>
        <p:spPr>
          <a:xfrm>
            <a:off x="1102953" y="6370345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00-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D402489-5A4C-6318-2255-6AB1C729EBC0}"/>
              </a:ext>
            </a:extLst>
          </p:cNvPr>
          <p:cNvSpPr txBox="1"/>
          <p:nvPr/>
        </p:nvSpPr>
        <p:spPr>
          <a:xfrm>
            <a:off x="4549736" y="1653799"/>
            <a:ext cx="8407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-Ser2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E4790B6-63F9-4232-7148-E8FF6FFD92B0}"/>
              </a:ext>
            </a:extLst>
          </p:cNvPr>
          <p:cNvSpPr txBox="1"/>
          <p:nvPr/>
        </p:nvSpPr>
        <p:spPr>
          <a:xfrm>
            <a:off x="4481076" y="3249094"/>
            <a:ext cx="840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Ser5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252C6E62-3F31-E9C6-FDBE-DC6C5276910C}"/>
              </a:ext>
            </a:extLst>
          </p:cNvPr>
          <p:cNvSpPr txBox="1"/>
          <p:nvPr/>
        </p:nvSpPr>
        <p:spPr>
          <a:xfrm>
            <a:off x="4441290" y="4665882"/>
            <a:ext cx="840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Ser7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38E97341-B357-5BC7-7C56-62D9E8875DCA}"/>
              </a:ext>
            </a:extLst>
          </p:cNvPr>
          <p:cNvSpPr txBox="1"/>
          <p:nvPr/>
        </p:nvSpPr>
        <p:spPr>
          <a:xfrm>
            <a:off x="4697683" y="6404067"/>
            <a:ext cx="613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PolII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7826FA58-5F56-1C65-A691-329166A03196}"/>
              </a:ext>
            </a:extLst>
          </p:cNvPr>
          <p:cNvSpPr txBox="1"/>
          <p:nvPr/>
        </p:nvSpPr>
        <p:spPr>
          <a:xfrm>
            <a:off x="10750033" y="1370045"/>
            <a:ext cx="9619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CDK2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4B36699-554A-E598-6086-ED70804A0848}"/>
              </a:ext>
            </a:extLst>
          </p:cNvPr>
          <p:cNvSpPr txBox="1"/>
          <p:nvPr/>
        </p:nvSpPr>
        <p:spPr>
          <a:xfrm>
            <a:off x="10885224" y="3036636"/>
            <a:ext cx="7585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DK2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11C9CE1-280C-7ECA-C2E8-018BBB495E2E}"/>
              </a:ext>
            </a:extLst>
          </p:cNvPr>
          <p:cNvSpPr txBox="1"/>
          <p:nvPr/>
        </p:nvSpPr>
        <p:spPr>
          <a:xfrm>
            <a:off x="10972155" y="4756731"/>
            <a:ext cx="7585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DK7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14F71547-D913-308F-E594-F4E2E30CB2A6}"/>
              </a:ext>
            </a:extLst>
          </p:cNvPr>
          <p:cNvSpPr txBox="1"/>
          <p:nvPr/>
        </p:nvSpPr>
        <p:spPr>
          <a:xfrm>
            <a:off x="10906433" y="6407341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ß-actin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09D00E3F-08B5-651B-C179-5F294FDA1B4B}"/>
              </a:ext>
            </a:extLst>
          </p:cNvPr>
          <p:cNvSpPr txBox="1"/>
          <p:nvPr/>
        </p:nvSpPr>
        <p:spPr>
          <a:xfrm>
            <a:off x="-17913" y="6676"/>
            <a:ext cx="49677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Fig EV 3E (</a:t>
            </a:r>
            <a:r>
              <a:rPr lang="en-US" sz="2400" dirty="0" err="1"/>
              <a:t>Bioreps</a:t>
            </a:r>
            <a:r>
              <a:rPr lang="en-US" sz="2400" dirty="0"/>
              <a:t> for quantification)</a:t>
            </a:r>
          </a:p>
        </p:txBody>
      </p:sp>
    </p:spTree>
    <p:extLst>
      <p:ext uri="{BB962C8B-B14F-4D97-AF65-F5344CB8AC3E}">
        <p14:creationId xmlns:p14="http://schemas.microsoft.com/office/powerpoint/2010/main" val="37737237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63</TotalTime>
  <Words>90</Words>
  <Application>Microsoft Macintosh PowerPoint</Application>
  <PresentationFormat>Widescreen</PresentationFormat>
  <Paragraphs>76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ai, Chun Fui</dc:creator>
  <cp:lastModifiedBy>Ali, Simak</cp:lastModifiedBy>
  <cp:revision>27</cp:revision>
  <dcterms:created xsi:type="dcterms:W3CDTF">2024-08-20T10:33:57Z</dcterms:created>
  <dcterms:modified xsi:type="dcterms:W3CDTF">2025-07-30T14:35:08Z</dcterms:modified>
</cp:coreProperties>
</file>